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F686F-49D9-4CD0-B7AF-AD5E2D4328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6E4FE-907F-4A7B-A3F0-84BDC1FE91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9C499-77DB-402B-BC91-DCABAF4F04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76621-FA28-4FB9-B33F-87B16A0D81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456BA-4BE2-4C5A-958A-7C6665EC1D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5F893-ADCE-4865-86FB-90E17609AA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99C30-1FBC-496E-BA80-98E4682CCC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759EC-22D9-4673-9F90-426FD44962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B5641-59C4-45F6-B171-B45D7DEFDB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DD5F2D-5DAD-4CF6-A0F9-781F68EE04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D26A5C-06D5-4E46-8928-EAD2D18959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F6982-6847-42B4-BBBF-9E81207D51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1E9B8C-7716-4F48-9A8D-3D407FD6113A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689280" y="15764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702320" y="15764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140000" y="157644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5025240" y="1440000"/>
            <a:ext cx="90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/C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is-regulation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3713040" y="18082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4219560" y="18082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4713120" y="18082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714480" y="20239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221000" y="20239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714560" y="20239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3659040" y="227016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4165200" y="227016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4659120" y="227016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660480" y="250020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167000" y="250020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4660560" y="250020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3714480" y="2755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221000" y="2755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4714560" y="2755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3716280" y="2971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4222440" y="2971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4716360" y="297180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3716280" y="32194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4222440" y="32194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4716360" y="32194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3717720" y="34354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224240" y="34354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717800" y="34354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3671640" y="367992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178160" y="367992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4671720" y="367992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3673080" y="389556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179600" y="389556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673520" y="389556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3681000" y="413388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187520" y="413388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668480" y="413388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3720960" y="43498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4190760" y="4349880"/>
            <a:ext cx="282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4721040" y="43498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3716280" y="45752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4222440" y="45752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4716360" y="45752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3717720" y="47912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4224240" y="47912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4717800" y="47912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2895480" y="4564080"/>
            <a:ext cx="29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2895480" y="2260440"/>
            <a:ext cx="29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2895480" y="2733840"/>
            <a:ext cx="29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2895480" y="3189240"/>
            <a:ext cx="29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2895480" y="3668760"/>
            <a:ext cx="29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2895480" y="4122720"/>
            <a:ext cx="29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2895480" y="1798560"/>
            <a:ext cx="2971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2895480" y="5010120"/>
            <a:ext cx="2971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3939120" y="1336680"/>
            <a:ext cx="70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eatmen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3746520" y="1536840"/>
            <a:ext cx="1143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2346480" y="5181480"/>
            <a:ext cx="40636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Additional File 9. ‘Metric’ classification scheme used to classify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genes according to their expression profile across all treatments.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2324880" y="1916280"/>
            <a:ext cx="569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ene 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2324880" y="2394000"/>
            <a:ext cx="569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ene B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2325240" y="2859120"/>
            <a:ext cx="57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ene 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2318760" y="3313080"/>
            <a:ext cx="57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ene D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2318760" y="3786120"/>
            <a:ext cx="569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ene 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2323080" y="424332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ene F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2323800" y="4680000"/>
            <a:ext cx="581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ene G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5376600" y="192564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5367600" y="240336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5271480" y="3335400"/>
            <a:ext cx="45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_L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5262480" y="3809880"/>
            <a:ext cx="47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C_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5303520" y="4243320"/>
            <a:ext cx="390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_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5335560" y="2867040"/>
            <a:ext cx="32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5198400" y="4686480"/>
            <a:ext cx="601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_LC_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3197160" y="180828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3086280" y="2023920"/>
            <a:ext cx="482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li18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3197160" y="227016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3086280" y="2500200"/>
            <a:ext cx="482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li18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3197160" y="275580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3086280" y="2971800"/>
            <a:ext cx="482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li18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3197160" y="322416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3086280" y="3440160"/>
            <a:ext cx="482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li18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3197160" y="367992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3086280" y="3895560"/>
            <a:ext cx="482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li18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3197160" y="413388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3086280" y="4349880"/>
            <a:ext cx="482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li18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3197160" y="457668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3086280" y="4792680"/>
            <a:ext cx="482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cli18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2971800" y="1584360"/>
            <a:ext cx="678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enotyp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5180040" y="187812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5105520" y="187164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5105520" y="219240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5180040" y="235584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5105520" y="235260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5180040" y="281952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5105520" y="281628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5105520" y="313200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5180040" y="328788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5105520" y="328788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5105520" y="359568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5180040" y="375444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5105520" y="375120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5105520" y="405936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5180040" y="419724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5105520" y="419724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5105520" y="450540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5180040" y="464040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5105520" y="464040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5105520" y="494496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5108400" y="266544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18:14:57Z</dcterms:created>
  <dc:creator>Allen Ingling</dc:creator>
  <dc:description/>
  <dc:language>en-US</dc:language>
  <cp:lastModifiedBy>admin</cp:lastModifiedBy>
  <dcterms:modified xsi:type="dcterms:W3CDTF">2008-03-11T06:11:40Z</dcterms:modified>
  <cp:revision>3</cp:revision>
  <dc:subject/>
  <dc:title>PowerPoint Presentation</dc:title>
</cp:coreProperties>
</file>